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5A660-DB96-4370-BF51-863552D41A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101F7-5ED1-4ADD-B0BD-69089FC0DC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8DAB9-8DFC-4CD2-A6DE-25EC052F30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022ED-2BF1-49FF-A99B-C316D728A5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35795-F99D-4D97-A203-6E114BA886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0958A-037E-48BB-98C5-F35004717B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70035-8991-471D-A9CF-919406B528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8D3EC-A997-49E9-95D4-EB1559F245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C5555-FF63-404F-9752-6B317D4BFB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6555F-4026-45B1-897C-370307A6C9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2778C-4D70-4316-A0C9-01812BDEC5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B36609-58F9-4900-A1DB-561D34FF65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AD4979-30C5-4F3B-AE4D-A8662798BBF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41480" y="2438280"/>
            <a:ext cx="7238880" cy="459720"/>
            <a:chOff x="1041480" y="2438280"/>
            <a:chExt cx="7238880" cy="459720"/>
          </a:xfrm>
        </p:grpSpPr>
        <p:sp>
          <p:nvSpPr>
            <p:cNvPr id="42" name=""/>
            <p:cNvSpPr/>
            <p:nvPr/>
          </p:nvSpPr>
          <p:spPr>
            <a:xfrm>
              <a:off x="2082960" y="2514240"/>
              <a:ext cx="556236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930320" y="2438280"/>
              <a:ext cx="990720" cy="2156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N-end(50bp)GF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207040" y="2438280"/>
              <a:ext cx="990720" cy="2156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C-end(50bp)GF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273720" y="2438280"/>
              <a:ext cx="1371600" cy="215640"/>
            </a:xfrm>
            <a:prstGeom prst="rect">
              <a:avLst/>
            </a:prstGeom>
            <a:solidFill>
              <a:srgbClr val="cc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pMOD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549440" y="2438280"/>
              <a:ext cx="457200" cy="215640"/>
            </a:xfrm>
            <a:prstGeom prst="rect">
              <a:avLst/>
            </a:prstGeom>
            <a:solidFill>
              <a:srgbClr val="9966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FL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454560" y="2438280"/>
              <a:ext cx="106668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368960" y="2438280"/>
              <a:ext cx="91440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844720" y="2438280"/>
              <a:ext cx="685800" cy="215640"/>
            </a:xfrm>
            <a:prstGeom prst="rect">
              <a:avLst/>
            </a:prstGeom>
            <a:solidFill>
              <a:srgbClr val="ff99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omp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041480" y="2514240"/>
              <a:ext cx="7238880" cy="266760"/>
            </a:xfrm>
            <a:custGeom>
              <a:avLst/>
              <a:gdLst/>
              <a:ahLst/>
              <a:rect l="l" t="t" r="r" b="b"/>
              <a:pathLst>
                <a:path w="4560" h="168">
                  <a:moveTo>
                    <a:pt x="320" y="48"/>
                  </a:moveTo>
                  <a:cubicBezTo>
                    <a:pt x="160" y="88"/>
                    <a:pt x="0" y="128"/>
                    <a:pt x="608" y="144"/>
                  </a:cubicBezTo>
                  <a:cubicBezTo>
                    <a:pt x="1216" y="160"/>
                    <a:pt x="3376" y="168"/>
                    <a:pt x="3968" y="144"/>
                  </a:cubicBezTo>
                  <a:cubicBezTo>
                    <a:pt x="4560" y="120"/>
                    <a:pt x="4360" y="60"/>
                    <a:pt x="4160" y="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064040" y="2666880"/>
              <a:ext cx="144792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MOD4 RT-G (4615 bp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"/>
          <p:cNvGrpSpPr/>
          <p:nvPr/>
        </p:nvGrpSpPr>
        <p:grpSpPr>
          <a:xfrm>
            <a:off x="1270080" y="4876920"/>
            <a:ext cx="6921360" cy="459720"/>
            <a:chOff x="1270080" y="4876920"/>
            <a:chExt cx="6921360" cy="459720"/>
          </a:xfrm>
        </p:grpSpPr>
        <p:sp>
          <p:nvSpPr>
            <p:cNvPr id="53" name=""/>
            <p:cNvSpPr/>
            <p:nvPr/>
          </p:nvSpPr>
          <p:spPr>
            <a:xfrm>
              <a:off x="1866960" y="5029560"/>
              <a:ext cx="5790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362640" y="4876920"/>
              <a:ext cx="1295280" cy="215640"/>
            </a:xfrm>
            <a:prstGeom prst="rect">
              <a:avLst/>
            </a:prstGeom>
            <a:solidFill>
              <a:srgbClr val="cc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MOD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552760" y="4876920"/>
              <a:ext cx="3733560" cy="2156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                      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GF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866960" y="4876920"/>
              <a:ext cx="685800" cy="215640"/>
            </a:xfrm>
            <a:prstGeom prst="rect">
              <a:avLst/>
            </a:prstGeom>
            <a:solidFill>
              <a:srgbClr val="9966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FL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270080" y="4953240"/>
              <a:ext cx="6921360" cy="266760"/>
            </a:xfrm>
            <a:custGeom>
              <a:avLst/>
              <a:gdLst/>
              <a:ahLst/>
              <a:rect l="l" t="t" r="r" b="b"/>
              <a:pathLst>
                <a:path w="4360" h="168">
                  <a:moveTo>
                    <a:pt x="376" y="0"/>
                  </a:moveTo>
                  <a:cubicBezTo>
                    <a:pt x="188" y="60"/>
                    <a:pt x="0" y="120"/>
                    <a:pt x="568" y="144"/>
                  </a:cubicBezTo>
                  <a:cubicBezTo>
                    <a:pt x="1136" y="168"/>
                    <a:pt x="3208" y="160"/>
                    <a:pt x="3784" y="144"/>
                  </a:cubicBezTo>
                  <a:cubicBezTo>
                    <a:pt x="4360" y="128"/>
                    <a:pt x="3984" y="64"/>
                    <a:pt x="4024" y="48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381560" y="5105520"/>
              <a:ext cx="182880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MOD4-FLAG-GFP ( 4029bp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"/>
          <p:cNvSpPr/>
          <p:nvPr/>
        </p:nvSpPr>
        <p:spPr>
          <a:xfrm>
            <a:off x="2209680" y="3733920"/>
            <a:ext cx="556272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971800" y="3657600"/>
            <a:ext cx="99072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-end(50bp)GF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029200" y="3657600"/>
            <a:ext cx="99072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-end(50bp)GF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590920" y="3657600"/>
            <a:ext cx="457200" cy="215640"/>
          </a:xfrm>
          <a:prstGeom prst="rect">
            <a:avLst/>
          </a:prstGeom>
          <a:solidFill>
            <a:srgbClr val="9966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962520" y="3657600"/>
            <a:ext cx="106668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al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523880" y="3657600"/>
            <a:ext cx="1067040" cy="215640"/>
          </a:xfrm>
          <a:prstGeom prst="rect">
            <a:avLst/>
          </a:prstGeom>
          <a:solidFill>
            <a:srgbClr val="a8f6b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-end(50bp)CT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80880" y="3657600"/>
            <a:ext cx="1143000" cy="215640"/>
          </a:xfrm>
          <a:prstGeom prst="rect">
            <a:avLst/>
          </a:prstGeom>
          <a:solidFill>
            <a:srgbClr val="00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-end(50bp)NT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019920" y="3657600"/>
            <a:ext cx="1066680" cy="215640"/>
          </a:xfrm>
          <a:prstGeom prst="rect">
            <a:avLst/>
          </a:prstGeom>
          <a:solidFill>
            <a:srgbClr val="a8f6b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-end(50bp) CT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7086600" y="3657600"/>
            <a:ext cx="1066680" cy="215640"/>
          </a:xfrm>
          <a:prstGeom prst="rect">
            <a:avLst/>
          </a:prstGeom>
          <a:solidFill>
            <a:srgbClr val="0099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-end(50bp)NT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0" y="3962520"/>
            <a:ext cx="9448920" cy="266760"/>
          </a:xfrm>
          <a:custGeom>
            <a:avLst/>
            <a:gdLst/>
            <a:ahLst/>
            <a:rect l="l" t="t" r="r" b="b"/>
            <a:pathLst>
              <a:path w="5952" h="168">
                <a:moveTo>
                  <a:pt x="160" y="0"/>
                </a:moveTo>
                <a:cubicBezTo>
                  <a:pt x="80" y="60"/>
                  <a:pt x="0" y="120"/>
                  <a:pt x="832" y="144"/>
                </a:cubicBezTo>
                <a:cubicBezTo>
                  <a:pt x="1664" y="168"/>
                  <a:pt x="4352" y="168"/>
                  <a:pt x="5152" y="144"/>
                </a:cubicBezTo>
                <a:cubicBezTo>
                  <a:pt x="5952" y="120"/>
                  <a:pt x="5792" y="60"/>
                  <a:pt x="5632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8153280" y="373392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8229600" y="3657600"/>
            <a:ext cx="914400" cy="215640"/>
          </a:xfrm>
          <a:prstGeom prst="rect">
            <a:avLst/>
          </a:prstGeom>
          <a:solidFill>
            <a:srgbClr val="cc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pMO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"/>
          <p:cNvGrpSpPr/>
          <p:nvPr/>
        </p:nvGrpSpPr>
        <p:grpSpPr>
          <a:xfrm>
            <a:off x="965160" y="5943600"/>
            <a:ext cx="7327800" cy="459720"/>
            <a:chOff x="965160" y="5943600"/>
            <a:chExt cx="7327800" cy="459720"/>
          </a:xfrm>
        </p:grpSpPr>
        <p:sp>
          <p:nvSpPr>
            <p:cNvPr id="72" name=""/>
            <p:cNvSpPr/>
            <p:nvPr/>
          </p:nvSpPr>
          <p:spPr>
            <a:xfrm>
              <a:off x="1549080" y="6095880"/>
              <a:ext cx="6095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6349680" y="5943600"/>
              <a:ext cx="1294920" cy="215640"/>
            </a:xfrm>
            <a:prstGeom prst="rect">
              <a:avLst/>
            </a:prstGeom>
            <a:solidFill>
              <a:srgbClr val="cc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pMOD4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234880" y="5943600"/>
              <a:ext cx="4038120" cy="215640"/>
            </a:xfrm>
            <a:prstGeom prst="rect">
              <a:avLst/>
            </a:prstGeom>
            <a:solidFill>
              <a:srgbClr val="99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                      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UNC-1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549080" y="5943600"/>
              <a:ext cx="761760" cy="215640"/>
            </a:xfrm>
            <a:prstGeom prst="rect">
              <a:avLst/>
            </a:prstGeom>
            <a:solidFill>
              <a:srgbClr val="ff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ox 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965160" y="6095880"/>
              <a:ext cx="7327800" cy="177840"/>
            </a:xfrm>
            <a:custGeom>
              <a:avLst/>
              <a:gdLst/>
              <a:ahLst/>
              <a:rect l="l" t="t" r="r" b="b"/>
              <a:pathLst>
                <a:path w="4616" h="112">
                  <a:moveTo>
                    <a:pt x="368" y="0"/>
                  </a:moveTo>
                  <a:cubicBezTo>
                    <a:pt x="184" y="40"/>
                    <a:pt x="0" y="80"/>
                    <a:pt x="608" y="96"/>
                  </a:cubicBezTo>
                  <a:cubicBezTo>
                    <a:pt x="1216" y="112"/>
                    <a:pt x="3416" y="112"/>
                    <a:pt x="4016" y="96"/>
                  </a:cubicBezTo>
                  <a:cubicBezTo>
                    <a:pt x="4616" y="80"/>
                    <a:pt x="4176" y="16"/>
                    <a:pt x="4208" y="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241520" y="6172200"/>
              <a:ext cx="1701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LoxP-UNC-119 ( 7846bp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"/>
          <p:cNvSpPr/>
          <p:nvPr/>
        </p:nvSpPr>
        <p:spPr>
          <a:xfrm>
            <a:off x="2019240" y="1523880"/>
            <a:ext cx="556272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400480" y="1447920"/>
            <a:ext cx="99036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-end(50bp)GF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143680" y="1447920"/>
            <a:ext cx="99036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-end(50bp)GF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210360" y="1447920"/>
            <a:ext cx="1371600" cy="215640"/>
          </a:xfrm>
          <a:prstGeom prst="rect">
            <a:avLst/>
          </a:prstGeom>
          <a:solidFill>
            <a:srgbClr val="cc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pMO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943280" y="1447920"/>
            <a:ext cx="457200" cy="215640"/>
          </a:xfrm>
          <a:prstGeom prst="rect">
            <a:avLst/>
          </a:prstGeom>
          <a:solidFill>
            <a:srgbClr val="9966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390840" y="1447920"/>
            <a:ext cx="182880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al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282680" y="1523880"/>
            <a:ext cx="6985080" cy="266760"/>
          </a:xfrm>
          <a:custGeom>
            <a:avLst/>
            <a:gdLst/>
            <a:ahLst/>
            <a:rect l="l" t="t" r="r" b="b"/>
            <a:pathLst>
              <a:path w="4400" h="168">
                <a:moveTo>
                  <a:pt x="424" y="0"/>
                </a:moveTo>
                <a:cubicBezTo>
                  <a:pt x="212" y="60"/>
                  <a:pt x="0" y="120"/>
                  <a:pt x="568" y="144"/>
                </a:cubicBezTo>
                <a:cubicBezTo>
                  <a:pt x="1136" y="168"/>
                  <a:pt x="3264" y="168"/>
                  <a:pt x="3832" y="144"/>
                </a:cubicBezTo>
                <a:cubicBezTo>
                  <a:pt x="4400" y="120"/>
                  <a:pt x="4188" y="60"/>
                  <a:pt x="3976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574640" y="3124080"/>
            <a:ext cx="4572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955880" y="2133720"/>
            <a:ext cx="419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31640" y="4419720"/>
            <a:ext cx="7696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174840" y="2895480"/>
            <a:ext cx="205740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548bp cassette for  RT recombineering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639960" y="1905120"/>
            <a:ext cx="215748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81bp cassette for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GalK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recombineering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258360" y="4191120"/>
            <a:ext cx="224460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612 bp  cassette for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GalK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recombineering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089240" y="1676520"/>
            <a:ext cx="16002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MOD4GalK-G (3462 bp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657600" y="4038480"/>
            <a:ext cx="15746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MOD4GalK-GT (3693 bp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657960" y="457200"/>
            <a:ext cx="15598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Vector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"/>
          <p:cNvSpPr/>
          <p:nvPr/>
        </p:nvSpPr>
        <p:spPr>
          <a:xfrm>
            <a:off x="1440000" y="1066680"/>
            <a:ext cx="380880" cy="228600"/>
          </a:xfrm>
          <a:prstGeom prst="line">
            <a:avLst/>
          </a:prstGeom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820880" y="1295280"/>
            <a:ext cx="304920" cy="0"/>
          </a:xfrm>
          <a:prstGeom prst="line">
            <a:avLst/>
          </a:prstGeom>
          <a:ln w="9360">
            <a:solidFill>
              <a:srgbClr val="cc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flipH="1">
            <a:off x="3726000" y="1676520"/>
            <a:ext cx="380880" cy="0"/>
          </a:xfrm>
          <a:prstGeom prst="line">
            <a:avLst/>
          </a:prstGeom>
          <a:ln w="93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106880" y="1676520"/>
            <a:ext cx="304920" cy="228600"/>
          </a:xfrm>
          <a:prstGeom prst="line">
            <a:avLst/>
          </a:prstGeom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350080" y="2057400"/>
            <a:ext cx="3044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High fidelity PCR, 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</a:rPr>
              <a:t>Dpn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I  digestion and gel–recovery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960720" y="1752480"/>
            <a:ext cx="161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0 bp homology arm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f</a:t>
            </a:r>
            <a:r>
              <a:rPr b="1" lang="en-US" sz="8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ff3300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74520" y="990720"/>
            <a:ext cx="161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0 bp homology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rm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f</a:t>
            </a:r>
            <a:r>
              <a:rPr b="0" lang="en-US" sz="8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ff3300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V="1">
            <a:off x="906480" y="2438280"/>
            <a:ext cx="419112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4261320" y="2362320"/>
            <a:ext cx="8240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50 bp of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982800" y="2362320"/>
            <a:ext cx="83808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50 bp of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780160" y="1101600"/>
            <a:ext cx="2921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ulture of Fosmid clone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ene of Interest (G.O.I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7078680" y="12952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782320" y="1371600"/>
            <a:ext cx="206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Extraction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Fosmid  DNA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780160" y="1752480"/>
            <a:ext cx="296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ransformation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</a:t>
            </a:r>
            <a:r>
              <a:rPr b="1" lang="en-US" sz="9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smid DNAs into SW106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7078680" y="16765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7078680" y="21337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783400" y="2286000"/>
            <a:ext cx="311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reparation of  SW106 Competent  cells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smid DNAs with induction in water bat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354400" y="190512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820880" y="2590920"/>
            <a:ext cx="2590920" cy="30456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058760" y="2590920"/>
            <a:ext cx="3581640" cy="30456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259160" y="2590920"/>
            <a:ext cx="762120" cy="30456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H="1">
            <a:off x="4640400" y="2590920"/>
            <a:ext cx="380880" cy="30456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878280" y="3276720"/>
            <a:ext cx="76320" cy="457200"/>
          </a:xfrm>
          <a:prstGeom prst="downArrow">
            <a:avLst>
              <a:gd name="adj1" fmla="val 50000"/>
              <a:gd name="adj2" fmla="val 149764"/>
            </a:avLst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957920" y="3962520"/>
            <a:ext cx="220968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461880" y="3962520"/>
            <a:ext cx="22748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878280" y="4952880"/>
            <a:ext cx="76320" cy="609840"/>
          </a:xfrm>
          <a:prstGeom prst="downArrow">
            <a:avLst>
              <a:gd name="adj1" fmla="val 50000"/>
              <a:gd name="adj2" fmla="val 199764"/>
            </a:avLst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114800" y="2895480"/>
            <a:ext cx="411480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                    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20320" y="3200400"/>
            <a:ext cx="333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1</a:t>
            </a:r>
            <a:r>
              <a:rPr b="1" lang="en-US" sz="900" spc="-1" strike="noStrike" u="sng" baseline="30000">
                <a:solidFill>
                  <a:srgbClr val="ff33cc"/>
                </a:solidFill>
                <a:uFillTx/>
                <a:latin typeface="Arial"/>
              </a:rPr>
              <a:t>st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  recombineering with</a:t>
            </a:r>
            <a:r>
              <a:rPr b="1" lang="en-US" sz="900" spc="-1" strike="noStrike" u="sng">
                <a:solidFill>
                  <a:srgbClr val="ff0000"/>
                </a:solidFill>
                <a:uFillTx/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RT positive selection (Tet+Chl+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H="1" flipV="1">
            <a:off x="2430000" y="4190760"/>
            <a:ext cx="3124440" cy="99036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flipH="1" flipV="1">
            <a:off x="3115800" y="4190760"/>
            <a:ext cx="1295640" cy="99036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640400" y="4191120"/>
            <a:ext cx="3962160" cy="99036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173560" y="4191120"/>
            <a:ext cx="2362320" cy="99036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5262480" y="5715000"/>
            <a:ext cx="22100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766800" y="5715000"/>
            <a:ext cx="22748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573360" y="2971800"/>
            <a:ext cx="5410440" cy="266760"/>
          </a:xfrm>
          <a:custGeom>
            <a:avLst/>
            <a:gdLst/>
            <a:ahLst/>
            <a:rect l="l" t="t" r="r" b="b"/>
            <a:pathLst>
              <a:path w="3664" h="168">
                <a:moveTo>
                  <a:pt x="336" y="0"/>
                </a:moveTo>
                <a:cubicBezTo>
                  <a:pt x="168" y="60"/>
                  <a:pt x="0" y="120"/>
                  <a:pt x="480" y="144"/>
                </a:cubicBezTo>
                <a:cubicBezTo>
                  <a:pt x="960" y="168"/>
                  <a:pt x="2768" y="168"/>
                  <a:pt x="3216" y="144"/>
                </a:cubicBezTo>
                <a:cubicBezTo>
                  <a:pt x="3664" y="120"/>
                  <a:pt x="3416" y="60"/>
                  <a:pt x="3168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-325440" y="4038480"/>
            <a:ext cx="8763120" cy="266760"/>
          </a:xfrm>
          <a:custGeom>
            <a:avLst/>
            <a:gdLst/>
            <a:ahLst/>
            <a:rect l="l" t="t" r="r" b="b"/>
            <a:pathLst>
              <a:path w="5520" h="168">
                <a:moveTo>
                  <a:pt x="488" y="0"/>
                </a:moveTo>
                <a:cubicBezTo>
                  <a:pt x="244" y="60"/>
                  <a:pt x="0" y="120"/>
                  <a:pt x="728" y="144"/>
                </a:cubicBezTo>
                <a:cubicBezTo>
                  <a:pt x="1456" y="168"/>
                  <a:pt x="4192" y="168"/>
                  <a:pt x="4856" y="144"/>
                </a:cubicBezTo>
                <a:cubicBezTo>
                  <a:pt x="5520" y="120"/>
                  <a:pt x="4736" y="24"/>
                  <a:pt x="4712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-96840" y="5867280"/>
            <a:ext cx="8852040" cy="177840"/>
          </a:xfrm>
          <a:custGeom>
            <a:avLst/>
            <a:gdLst/>
            <a:ahLst/>
            <a:rect l="l" t="t" r="r" b="b"/>
            <a:pathLst>
              <a:path w="5576" h="112">
                <a:moveTo>
                  <a:pt x="536" y="0"/>
                </a:moveTo>
                <a:cubicBezTo>
                  <a:pt x="268" y="40"/>
                  <a:pt x="0" y="80"/>
                  <a:pt x="728" y="96"/>
                </a:cubicBezTo>
                <a:cubicBezTo>
                  <a:pt x="1456" y="112"/>
                  <a:pt x="4232" y="112"/>
                  <a:pt x="4904" y="96"/>
                </a:cubicBezTo>
                <a:cubicBezTo>
                  <a:pt x="5576" y="80"/>
                  <a:pt x="5168" y="40"/>
                  <a:pt x="4760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7078680" y="2666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2443320" y="228600"/>
            <a:ext cx="45331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Original RT recombineering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8678880" y="1219320"/>
            <a:ext cx="76320" cy="1371600"/>
          </a:xfrm>
          <a:custGeom>
            <a:avLst/>
            <a:gdLst>
              <a:gd name="textAreaLeft" fmla="*/ 0 w 76320"/>
              <a:gd name="textAreaRight" fmla="*/ 53640 w 76320"/>
              <a:gd name="textAreaTop" fmla="*/ 56880 h 1371600"/>
              <a:gd name="textAreaBottom" fmla="*/ 1314720 h 1371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8740800" y="170964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8678880" y="2666880"/>
            <a:ext cx="76320" cy="990720"/>
          </a:xfrm>
          <a:custGeom>
            <a:avLst/>
            <a:gdLst>
              <a:gd name="textAreaLeft" fmla="*/ 0 w 76320"/>
              <a:gd name="textAreaRight" fmla="*/ 53640 w 76320"/>
              <a:gd name="textAreaTop" fmla="*/ 41040 h 990720"/>
              <a:gd name="textAreaBottom" fmla="*/ 949680 h 990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8731440" y="2971800"/>
            <a:ext cx="394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8678880" y="3733920"/>
            <a:ext cx="76320" cy="2286000"/>
          </a:xfrm>
          <a:custGeom>
            <a:avLst/>
            <a:gdLst>
              <a:gd name="textAreaLeft" fmla="*/ 0 w 76320"/>
              <a:gd name="textAreaRight" fmla="*/ 53640 w 76320"/>
              <a:gd name="textAreaTop" fmla="*/ 95040 h 2286000"/>
              <a:gd name="textAreaBottom" fmla="*/ 2190960 h 2286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8731440" y="4724280"/>
            <a:ext cx="394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33520" y="1447920"/>
            <a:ext cx="9064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BAC-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"/>
          <p:cNvGrpSpPr/>
          <p:nvPr/>
        </p:nvGrpSpPr>
        <p:grpSpPr>
          <a:xfrm>
            <a:off x="1820880" y="2362320"/>
            <a:ext cx="2438280" cy="215640"/>
            <a:chOff x="1820880" y="2362320"/>
            <a:chExt cx="2438280" cy="215640"/>
          </a:xfrm>
        </p:grpSpPr>
        <p:sp>
          <p:nvSpPr>
            <p:cNvPr id="141" name=""/>
            <p:cNvSpPr/>
            <p:nvPr/>
          </p:nvSpPr>
          <p:spPr>
            <a:xfrm>
              <a:off x="1820880" y="2362320"/>
              <a:ext cx="114300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963880" y="2362320"/>
              <a:ext cx="129528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3" name=""/>
          <p:cNvSpPr/>
          <p:nvPr/>
        </p:nvSpPr>
        <p:spPr>
          <a:xfrm>
            <a:off x="4333680" y="3276720"/>
            <a:ext cx="161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0 bp homology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rm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f</a:t>
            </a:r>
            <a:r>
              <a:rPr b="0" lang="en-US" sz="800" spc="-1" strike="noStrike">
                <a:solidFill>
                  <a:srgbClr val="ff33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ff3300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flipH="1">
            <a:off x="8221320" y="3886200"/>
            <a:ext cx="304920" cy="0"/>
          </a:xfrm>
          <a:prstGeom prst="line">
            <a:avLst/>
          </a:prstGeom>
          <a:ln w="9360">
            <a:solidFill>
              <a:srgbClr val="00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6012000" y="3429000"/>
            <a:ext cx="304560" cy="0"/>
          </a:xfrm>
          <a:prstGeom prst="line">
            <a:avLst/>
          </a:prstGeom>
          <a:ln w="9360">
            <a:solidFill>
              <a:srgbClr val="00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8526600" y="3886200"/>
            <a:ext cx="152280" cy="304920"/>
          </a:xfrm>
          <a:prstGeom prst="line">
            <a:avLst/>
          </a:prstGeom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5630760" y="3276720"/>
            <a:ext cx="381240" cy="152280"/>
          </a:xfrm>
          <a:prstGeom prst="line">
            <a:avLst/>
          </a:prstGeom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7993080" y="3886200"/>
            <a:ext cx="0" cy="10666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7002360" y="4343400"/>
            <a:ext cx="1676520" cy="489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0 bp homology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rm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f</a:t>
            </a:r>
            <a:r>
              <a:rPr b="0" lang="en-US" sz="8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ff3300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CR  and gel-recover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040200" y="5715000"/>
            <a:ext cx="227484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TAG (GFP or TA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583000" y="3962520"/>
            <a:ext cx="1143000" cy="215640"/>
          </a:xfrm>
          <a:prstGeom prst="rect">
            <a:avLst/>
          </a:prstGeom>
          <a:solidFill>
            <a:srgbClr val="99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         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rps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726000" y="3962520"/>
            <a:ext cx="1295280" cy="2156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         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Te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335480" y="5257800"/>
            <a:ext cx="4343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4" name=""/>
          <p:cNvGrpSpPr/>
          <p:nvPr/>
        </p:nvGrpSpPr>
        <p:grpSpPr>
          <a:xfrm>
            <a:off x="4413960" y="5105520"/>
            <a:ext cx="4176720" cy="366480"/>
            <a:chOff x="4413960" y="5105520"/>
            <a:chExt cx="4176720" cy="366480"/>
          </a:xfrm>
        </p:grpSpPr>
        <p:sp>
          <p:nvSpPr>
            <p:cNvPr id="155" name=""/>
            <p:cNvSpPr/>
            <p:nvPr/>
          </p:nvSpPr>
          <p:spPr>
            <a:xfrm>
              <a:off x="6453360" y="5105520"/>
              <a:ext cx="183960" cy="36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4413960" y="5145120"/>
              <a:ext cx="824040" cy="215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50 bp of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G.O.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7766640" y="5145120"/>
              <a:ext cx="824040" cy="215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50 bp of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G.O.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5173560" y="5145120"/>
              <a:ext cx="2590920" cy="2156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                                 </a:t>
              </a: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TAG ( GFP or TAP)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9" name=""/>
          <p:cNvSpPr/>
          <p:nvPr/>
        </p:nvSpPr>
        <p:spPr>
          <a:xfrm>
            <a:off x="5935680" y="3581280"/>
            <a:ext cx="2743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6012000" y="3505320"/>
            <a:ext cx="2606400" cy="231120"/>
          </a:xfrm>
          <a:prstGeom prst="rect">
            <a:avLst/>
          </a:prstGeom>
          <a:solidFill>
            <a:srgbClr val="00ff00"/>
          </a:solidFill>
          <a:ln w="93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ffff"/>
                </a:solidFill>
                <a:latin typeface="Arial"/>
              </a:rPr>
              <a:t>                        </a:t>
            </a:r>
            <a:r>
              <a:rPr b="0" lang="en-US" sz="900" spc="-1" strike="noStrike">
                <a:solidFill>
                  <a:srgbClr val="ffffff"/>
                </a:solidFill>
                <a:latin typeface="Arial"/>
              </a:rPr>
              <a:t>TAG ( GFP or TAP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668600" y="1447920"/>
            <a:ext cx="2806560" cy="266760"/>
          </a:xfrm>
          <a:custGeom>
            <a:avLst/>
            <a:gdLst/>
            <a:ahLst/>
            <a:rect l="l" t="t" r="r" b="b"/>
            <a:pathLst>
              <a:path w="1768" h="168">
                <a:moveTo>
                  <a:pt x="96" y="0"/>
                </a:moveTo>
                <a:cubicBezTo>
                  <a:pt x="48" y="60"/>
                  <a:pt x="0" y="120"/>
                  <a:pt x="240" y="144"/>
                </a:cubicBezTo>
                <a:cubicBezTo>
                  <a:pt x="480" y="168"/>
                  <a:pt x="1304" y="168"/>
                  <a:pt x="1536" y="144"/>
                </a:cubicBezTo>
                <a:cubicBezTo>
                  <a:pt x="1768" y="120"/>
                  <a:pt x="1616" y="24"/>
                  <a:pt x="1632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2" name=""/>
          <p:cNvGrpSpPr/>
          <p:nvPr/>
        </p:nvGrpSpPr>
        <p:grpSpPr>
          <a:xfrm>
            <a:off x="1820880" y="1371600"/>
            <a:ext cx="2438280" cy="337320"/>
            <a:chOff x="1820880" y="1371600"/>
            <a:chExt cx="2438280" cy="337320"/>
          </a:xfrm>
        </p:grpSpPr>
        <p:sp>
          <p:nvSpPr>
            <p:cNvPr id="163" name=""/>
            <p:cNvSpPr/>
            <p:nvPr/>
          </p:nvSpPr>
          <p:spPr>
            <a:xfrm>
              <a:off x="2278080" y="1371600"/>
              <a:ext cx="114300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3344760" y="1371600"/>
              <a:ext cx="91440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820880" y="1371600"/>
              <a:ext cx="533520" cy="337320"/>
            </a:xfrm>
            <a:prstGeom prst="rect">
              <a:avLst/>
            </a:prstGeom>
            <a:solidFill>
              <a:srgbClr val="cc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ompF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6" name=""/>
          <p:cNvGrpSpPr/>
          <p:nvPr/>
        </p:nvGrpSpPr>
        <p:grpSpPr>
          <a:xfrm>
            <a:off x="1820880" y="2362320"/>
            <a:ext cx="2438280" cy="337320"/>
            <a:chOff x="1820880" y="2362320"/>
            <a:chExt cx="2438280" cy="337320"/>
          </a:xfrm>
        </p:grpSpPr>
        <p:sp>
          <p:nvSpPr>
            <p:cNvPr id="167" name=""/>
            <p:cNvSpPr/>
            <p:nvPr/>
          </p:nvSpPr>
          <p:spPr>
            <a:xfrm>
              <a:off x="2278080" y="2362320"/>
              <a:ext cx="114300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3344760" y="2362320"/>
              <a:ext cx="91440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820880" y="2362320"/>
              <a:ext cx="533520" cy="337320"/>
            </a:xfrm>
            <a:prstGeom prst="rect">
              <a:avLst/>
            </a:prstGeom>
            <a:solidFill>
              <a:srgbClr val="cc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ompF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0" name=""/>
          <p:cNvGrpSpPr/>
          <p:nvPr/>
        </p:nvGrpSpPr>
        <p:grpSpPr>
          <a:xfrm>
            <a:off x="2583000" y="3962520"/>
            <a:ext cx="2438280" cy="337320"/>
            <a:chOff x="2583000" y="3962520"/>
            <a:chExt cx="2438280" cy="337320"/>
          </a:xfrm>
        </p:grpSpPr>
        <p:sp>
          <p:nvSpPr>
            <p:cNvPr id="171" name=""/>
            <p:cNvSpPr/>
            <p:nvPr/>
          </p:nvSpPr>
          <p:spPr>
            <a:xfrm>
              <a:off x="3040200" y="3962520"/>
              <a:ext cx="114300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106880" y="3962520"/>
              <a:ext cx="91440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583000" y="3962520"/>
              <a:ext cx="533520" cy="337320"/>
            </a:xfrm>
            <a:prstGeom prst="rect">
              <a:avLst/>
            </a:prstGeom>
            <a:solidFill>
              <a:srgbClr val="cc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ompF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4" name=""/>
          <p:cNvSpPr/>
          <p:nvPr/>
        </p:nvSpPr>
        <p:spPr>
          <a:xfrm>
            <a:off x="451080" y="4987800"/>
            <a:ext cx="289512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Preparation of Competent cell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2</a:t>
            </a:r>
            <a:r>
              <a:rPr b="1" lang="en-US" sz="900" spc="-1" strike="noStrike" u="sng" baseline="30000">
                <a:solidFill>
                  <a:srgbClr val="3333cc"/>
                </a:solidFill>
                <a:uFillTx/>
                <a:latin typeface="Arial"/>
              </a:rPr>
              <a:t>nd</a:t>
            </a: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 recombineering with </a:t>
            </a:r>
            <a:r>
              <a:rPr b="1" lang="en-US" sz="900" spc="-1" strike="noStrike" u="sng">
                <a:solidFill>
                  <a:srgbClr val="009900"/>
                </a:solidFill>
                <a:uFillTx/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0000ff"/>
                </a:solidFill>
                <a:uFillTx/>
                <a:latin typeface="Arial"/>
              </a:rPr>
              <a:t>RT</a:t>
            </a:r>
            <a:r>
              <a:rPr b="1" lang="en-US" sz="900" spc="-1" strike="noStrike" u="sng">
                <a:solidFill>
                  <a:srgbClr val="009900"/>
                </a:solidFill>
                <a:uFillTx/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negative selection 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hypotonic media (Str+Chl+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754200" y="5943600"/>
            <a:ext cx="76176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449280" y="419112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4106880" y="312408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"/>
          <p:cNvSpPr/>
          <p:nvPr/>
        </p:nvSpPr>
        <p:spPr>
          <a:xfrm>
            <a:off x="762120" y="380880"/>
            <a:ext cx="380880" cy="228600"/>
          </a:xfrm>
          <a:prstGeom prst="line">
            <a:avLst/>
          </a:prstGeom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1143000" y="609480"/>
            <a:ext cx="228600" cy="0"/>
          </a:xfrm>
          <a:prstGeom prst="line">
            <a:avLst/>
          </a:prstGeom>
          <a:ln w="9360">
            <a:solidFill>
              <a:srgbClr val="00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H="1">
            <a:off x="3428640" y="1066680"/>
            <a:ext cx="228600" cy="0"/>
          </a:xfrm>
          <a:prstGeom prst="line">
            <a:avLst/>
          </a:prstGeom>
          <a:ln w="9360">
            <a:solidFill>
              <a:srgbClr val="00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657600" y="1066680"/>
            <a:ext cx="304920" cy="228600"/>
          </a:xfrm>
          <a:prstGeom prst="line">
            <a:avLst/>
          </a:prstGeom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3884400" y="1143000"/>
            <a:ext cx="161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0 bp homology arm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f</a:t>
            </a:r>
            <a:r>
              <a:rPr b="1" lang="en-US" sz="8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ff3300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-1800" y="304920"/>
            <a:ext cx="161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0 bp homology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rm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f</a:t>
            </a:r>
            <a:r>
              <a:rPr b="0" lang="en-US" sz="8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ff3300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V="1">
            <a:off x="914400" y="1828800"/>
            <a:ext cx="419112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269240" y="1752480"/>
            <a:ext cx="8240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50 bp of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990720" y="1752480"/>
            <a:ext cx="91440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50 bp of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5788080" y="492120"/>
            <a:ext cx="2921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ulture of Fosmid clone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ene of Interest (G.O.I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7086600" y="6858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5790240" y="762120"/>
            <a:ext cx="206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Extraction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smid  DNA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5788080" y="1143000"/>
            <a:ext cx="296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ransformation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smid DNAs into SW106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7086600" y="10666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7086600" y="1523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5791320" y="1676520"/>
            <a:ext cx="311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reparation of  SW106 Competent  cells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</a:t>
            </a:r>
            <a:r>
              <a:rPr b="1" lang="en-US" sz="900" spc="-1" strike="noStrike">
                <a:solidFill>
                  <a:srgbClr val="00ffff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smid DNAs with induction in water bat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209680" y="13716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1828800" y="1981080"/>
            <a:ext cx="2590920" cy="30492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1066680" y="1981080"/>
            <a:ext cx="3581640" cy="30492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4267080" y="1981080"/>
            <a:ext cx="762120" cy="30492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flipH="1">
            <a:off x="4648320" y="1981080"/>
            <a:ext cx="380880" cy="30492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3886200" y="2666880"/>
            <a:ext cx="76320" cy="457200"/>
          </a:xfrm>
          <a:prstGeom prst="downArrow">
            <a:avLst>
              <a:gd name="adj1" fmla="val 50000"/>
              <a:gd name="adj2" fmla="val 149764"/>
            </a:avLst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4965840" y="3352680"/>
            <a:ext cx="220968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469800" y="3352680"/>
            <a:ext cx="22748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886200" y="4343400"/>
            <a:ext cx="76320" cy="609480"/>
          </a:xfrm>
          <a:prstGeom prst="downArrow">
            <a:avLst>
              <a:gd name="adj1" fmla="val 50000"/>
              <a:gd name="adj2" fmla="val 199646"/>
            </a:avLst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4114800" y="2286000"/>
            <a:ext cx="411480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                    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28240" y="2590920"/>
            <a:ext cx="333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1</a:t>
            </a:r>
            <a:r>
              <a:rPr b="1" lang="en-US" sz="900" spc="-1" strike="noStrike" u="sng" baseline="30000">
                <a:solidFill>
                  <a:srgbClr val="ff33cc"/>
                </a:solidFill>
                <a:uFillTx/>
                <a:latin typeface="Arial"/>
              </a:rPr>
              <a:t>st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  recombineering with</a:t>
            </a:r>
            <a:r>
              <a:rPr b="1" lang="en-US" sz="900" spc="-1" strike="noStrike" u="sng">
                <a:solidFill>
                  <a:srgbClr val="ff0000"/>
                </a:solidFill>
                <a:uFillTx/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RT positive selection (Tet+Chl+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8155440" y="3646440"/>
            <a:ext cx="43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o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 flipH="1">
            <a:off x="3200040" y="3124080"/>
            <a:ext cx="304812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flipH="1">
            <a:off x="2742840" y="3124080"/>
            <a:ext cx="3809880" cy="22860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flipV="1">
            <a:off x="4572000" y="3123720"/>
            <a:ext cx="403848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flipV="1">
            <a:off x="4876920" y="3123720"/>
            <a:ext cx="3733560" cy="22860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flipH="1" flipV="1">
            <a:off x="2209680" y="3581280"/>
            <a:ext cx="3276720" cy="106704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H="1" flipV="1">
            <a:off x="2742840" y="3581280"/>
            <a:ext cx="1676520" cy="99072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4876920" y="3581280"/>
            <a:ext cx="3657600" cy="99072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5181480" y="3581280"/>
            <a:ext cx="2362320" cy="99072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3060720" y="5105520"/>
            <a:ext cx="227484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TAG ( GFP or TA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5270400" y="5105520"/>
            <a:ext cx="22100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774720" y="5105520"/>
            <a:ext cx="22748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3581280" y="2362320"/>
            <a:ext cx="5410440" cy="266760"/>
          </a:xfrm>
          <a:custGeom>
            <a:avLst/>
            <a:gdLst/>
            <a:ahLst/>
            <a:rect l="l" t="t" r="r" b="b"/>
            <a:pathLst>
              <a:path w="3664" h="168">
                <a:moveTo>
                  <a:pt x="336" y="0"/>
                </a:moveTo>
                <a:cubicBezTo>
                  <a:pt x="168" y="60"/>
                  <a:pt x="0" y="120"/>
                  <a:pt x="480" y="144"/>
                </a:cubicBezTo>
                <a:cubicBezTo>
                  <a:pt x="960" y="168"/>
                  <a:pt x="2768" y="168"/>
                  <a:pt x="3216" y="144"/>
                </a:cubicBezTo>
                <a:cubicBezTo>
                  <a:pt x="3664" y="120"/>
                  <a:pt x="3416" y="60"/>
                  <a:pt x="3168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-317520" y="3429000"/>
            <a:ext cx="8763120" cy="266760"/>
          </a:xfrm>
          <a:custGeom>
            <a:avLst/>
            <a:gdLst/>
            <a:ahLst/>
            <a:rect l="l" t="t" r="r" b="b"/>
            <a:pathLst>
              <a:path w="5520" h="168">
                <a:moveTo>
                  <a:pt x="488" y="0"/>
                </a:moveTo>
                <a:cubicBezTo>
                  <a:pt x="244" y="60"/>
                  <a:pt x="0" y="120"/>
                  <a:pt x="728" y="144"/>
                </a:cubicBezTo>
                <a:cubicBezTo>
                  <a:pt x="1456" y="168"/>
                  <a:pt x="4192" y="168"/>
                  <a:pt x="4856" y="144"/>
                </a:cubicBezTo>
                <a:cubicBezTo>
                  <a:pt x="5520" y="120"/>
                  <a:pt x="4736" y="24"/>
                  <a:pt x="4712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-88920" y="5257800"/>
            <a:ext cx="8852040" cy="177840"/>
          </a:xfrm>
          <a:custGeom>
            <a:avLst/>
            <a:gdLst/>
            <a:ahLst/>
            <a:rect l="l" t="t" r="r" b="b"/>
            <a:pathLst>
              <a:path w="5576" h="112">
                <a:moveTo>
                  <a:pt x="536" y="0"/>
                </a:moveTo>
                <a:cubicBezTo>
                  <a:pt x="268" y="40"/>
                  <a:pt x="0" y="80"/>
                  <a:pt x="728" y="96"/>
                </a:cubicBezTo>
                <a:cubicBezTo>
                  <a:pt x="1456" y="112"/>
                  <a:pt x="4232" y="112"/>
                  <a:pt x="4904" y="96"/>
                </a:cubicBezTo>
                <a:cubicBezTo>
                  <a:pt x="5576" y="80"/>
                  <a:pt x="5168" y="40"/>
                  <a:pt x="4760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3886200" y="5715000"/>
            <a:ext cx="76320" cy="609480"/>
          </a:xfrm>
          <a:prstGeom prst="downArrow">
            <a:avLst>
              <a:gd name="adj1" fmla="val 50000"/>
              <a:gd name="adj2" fmla="val 199646"/>
            </a:avLst>
          </a:prstGeom>
          <a:solidFill>
            <a:srgbClr val="cc00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4572000" y="5715000"/>
            <a:ext cx="3657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7010280" y="5638680"/>
            <a:ext cx="1143000" cy="215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MO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5334120" y="5638680"/>
            <a:ext cx="1600200" cy="215640"/>
          </a:xfrm>
          <a:prstGeom prst="rect">
            <a:avLst/>
          </a:prstGeom>
          <a:solidFill>
            <a:srgbClr val="99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UNC-1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4572000" y="563868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4165560" y="5715000"/>
            <a:ext cx="4775400" cy="266760"/>
          </a:xfrm>
          <a:custGeom>
            <a:avLst/>
            <a:gdLst/>
            <a:ahLst/>
            <a:rect l="l" t="t" r="r" b="b"/>
            <a:pathLst>
              <a:path w="3008" h="168">
                <a:moveTo>
                  <a:pt x="256" y="0"/>
                </a:moveTo>
                <a:cubicBezTo>
                  <a:pt x="128" y="60"/>
                  <a:pt x="0" y="120"/>
                  <a:pt x="400" y="144"/>
                </a:cubicBezTo>
                <a:cubicBezTo>
                  <a:pt x="800" y="168"/>
                  <a:pt x="2304" y="168"/>
                  <a:pt x="2656" y="144"/>
                </a:cubicBezTo>
                <a:cubicBezTo>
                  <a:pt x="3008" y="120"/>
                  <a:pt x="2536" y="24"/>
                  <a:pt x="2512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6400800" y="5867280"/>
            <a:ext cx="9907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oxP-UNC-11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00600" y="5867280"/>
            <a:ext cx="358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99cc00"/>
                </a:solidFill>
                <a:uFillTx/>
                <a:latin typeface="Arial"/>
              </a:rPr>
              <a:t>pLoxP / Cre recombineering with 0.1% arabinose (AMP+Chl+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2666880" y="6400800"/>
            <a:ext cx="209412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TAG ( GFP or TA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4748040" y="6400800"/>
            <a:ext cx="20336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609480" y="6400800"/>
            <a:ext cx="209412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6858000" y="6400800"/>
            <a:ext cx="1143000" cy="215640"/>
          </a:xfrm>
          <a:prstGeom prst="rect">
            <a:avLst/>
          </a:prstGeom>
          <a:solidFill>
            <a:srgbClr val="99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UNC-1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-380880" y="6477120"/>
            <a:ext cx="9372600" cy="266760"/>
          </a:xfrm>
          <a:custGeom>
            <a:avLst/>
            <a:gdLst/>
            <a:ahLst/>
            <a:rect l="l" t="t" r="r" b="b"/>
            <a:pathLst>
              <a:path w="6168" h="168">
                <a:moveTo>
                  <a:pt x="648" y="0"/>
                </a:moveTo>
                <a:cubicBezTo>
                  <a:pt x="324" y="60"/>
                  <a:pt x="0" y="120"/>
                  <a:pt x="792" y="144"/>
                </a:cubicBezTo>
                <a:cubicBezTo>
                  <a:pt x="1584" y="168"/>
                  <a:pt x="4632" y="160"/>
                  <a:pt x="5400" y="144"/>
                </a:cubicBezTo>
                <a:cubicBezTo>
                  <a:pt x="6168" y="128"/>
                  <a:pt x="5400" y="64"/>
                  <a:pt x="5400" y="48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6781680" y="655308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7086600" y="20574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5792400" y="5334120"/>
            <a:ext cx="3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99cc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2892960" y="152280"/>
            <a:ext cx="3583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Modified  RT  recombineering</a:t>
            </a:r>
            <a:r>
              <a:rPr b="0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8686800" y="609480"/>
            <a:ext cx="76320" cy="1371600"/>
          </a:xfrm>
          <a:custGeom>
            <a:avLst/>
            <a:gdLst>
              <a:gd name="textAreaLeft" fmla="*/ 0 w 76320"/>
              <a:gd name="textAreaRight" fmla="*/ 53640 w 76320"/>
              <a:gd name="textAreaTop" fmla="*/ 56880 h 1371600"/>
              <a:gd name="textAreaBottom" fmla="*/ 1314720 h 1371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8748720" y="110016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8686800" y="2057400"/>
            <a:ext cx="76320" cy="990720"/>
          </a:xfrm>
          <a:custGeom>
            <a:avLst/>
            <a:gdLst>
              <a:gd name="textAreaLeft" fmla="*/ 0 w 76320"/>
              <a:gd name="textAreaRight" fmla="*/ 53640 w 76320"/>
              <a:gd name="textAreaTop" fmla="*/ 41040 h 990720"/>
              <a:gd name="textAreaBottom" fmla="*/ 949680 h 990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8739720" y="2362320"/>
            <a:ext cx="394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8686800" y="3124080"/>
            <a:ext cx="76320" cy="2286000"/>
          </a:xfrm>
          <a:custGeom>
            <a:avLst/>
            <a:gdLst>
              <a:gd name="textAreaLeft" fmla="*/ 0 w 76320"/>
              <a:gd name="textAreaRight" fmla="*/ 53640 w 76320"/>
              <a:gd name="textAreaTop" fmla="*/ 95040 h 2286000"/>
              <a:gd name="textAreaBottom" fmla="*/ 2190960 h 2286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8739720" y="4114800"/>
            <a:ext cx="394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8740800" y="563868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8686800" y="5486400"/>
            <a:ext cx="76320" cy="1295280"/>
          </a:xfrm>
          <a:custGeom>
            <a:avLst/>
            <a:gdLst>
              <a:gd name="textAreaLeft" fmla="*/ 0 w 76320"/>
              <a:gd name="textAreaRight" fmla="*/ 53640 w 76320"/>
              <a:gd name="textAreaTop" fmla="*/ 53640 h 1295280"/>
              <a:gd name="textAreaBottom" fmla="*/ 1241640 h 1295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0" y="838080"/>
            <a:ext cx="12193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MOD4RT-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3657600" y="762120"/>
            <a:ext cx="685800" cy="215640"/>
          </a:xfrm>
          <a:prstGeom prst="rect">
            <a:avLst/>
          </a:prstGeom>
          <a:solidFill>
            <a:srgbClr val="cc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MO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7" name=""/>
          <p:cNvGrpSpPr/>
          <p:nvPr/>
        </p:nvGrpSpPr>
        <p:grpSpPr>
          <a:xfrm>
            <a:off x="1828800" y="1752480"/>
            <a:ext cx="2438280" cy="215640"/>
            <a:chOff x="1828800" y="1752480"/>
            <a:chExt cx="2438280" cy="215640"/>
          </a:xfrm>
        </p:grpSpPr>
        <p:sp>
          <p:nvSpPr>
            <p:cNvPr id="248" name=""/>
            <p:cNvSpPr/>
            <p:nvPr/>
          </p:nvSpPr>
          <p:spPr>
            <a:xfrm>
              <a:off x="2286000" y="1752480"/>
              <a:ext cx="68580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2971800" y="1752480"/>
              <a:ext cx="83808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1828800" y="1752480"/>
              <a:ext cx="457200" cy="2145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809880" y="1752480"/>
              <a:ext cx="457200" cy="2145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2" name=""/>
          <p:cNvGrpSpPr/>
          <p:nvPr/>
        </p:nvGrpSpPr>
        <p:grpSpPr>
          <a:xfrm>
            <a:off x="2590920" y="3352680"/>
            <a:ext cx="2438280" cy="215640"/>
            <a:chOff x="2590920" y="3352680"/>
            <a:chExt cx="2438280" cy="215640"/>
          </a:xfrm>
        </p:grpSpPr>
        <p:sp>
          <p:nvSpPr>
            <p:cNvPr id="253" name=""/>
            <p:cNvSpPr/>
            <p:nvPr/>
          </p:nvSpPr>
          <p:spPr>
            <a:xfrm>
              <a:off x="3048120" y="3352680"/>
              <a:ext cx="68580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733920" y="3352680"/>
              <a:ext cx="83808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590920" y="3352680"/>
              <a:ext cx="457200" cy="2145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4572000" y="3352680"/>
              <a:ext cx="457200" cy="2145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7" name=""/>
          <p:cNvGrpSpPr/>
          <p:nvPr/>
        </p:nvGrpSpPr>
        <p:grpSpPr>
          <a:xfrm>
            <a:off x="1219320" y="762120"/>
            <a:ext cx="2438280" cy="215640"/>
            <a:chOff x="1219320" y="762120"/>
            <a:chExt cx="2438280" cy="215640"/>
          </a:xfrm>
        </p:grpSpPr>
        <p:sp>
          <p:nvSpPr>
            <p:cNvPr id="258" name=""/>
            <p:cNvSpPr/>
            <p:nvPr/>
          </p:nvSpPr>
          <p:spPr>
            <a:xfrm>
              <a:off x="1676520" y="762120"/>
              <a:ext cx="68580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362320" y="762120"/>
              <a:ext cx="83808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1219320" y="762120"/>
              <a:ext cx="457200" cy="2142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3200400" y="762120"/>
              <a:ext cx="457200" cy="2142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2" name=""/>
          <p:cNvSpPr/>
          <p:nvPr/>
        </p:nvSpPr>
        <p:spPr>
          <a:xfrm>
            <a:off x="914400" y="914400"/>
            <a:ext cx="3975120" cy="266760"/>
          </a:xfrm>
          <a:custGeom>
            <a:avLst/>
            <a:gdLst/>
            <a:ahLst/>
            <a:rect l="l" t="t" r="r" b="b"/>
            <a:pathLst>
              <a:path w="2504" h="168">
                <a:moveTo>
                  <a:pt x="192" y="0"/>
                </a:moveTo>
                <a:cubicBezTo>
                  <a:pt x="96" y="60"/>
                  <a:pt x="0" y="120"/>
                  <a:pt x="336" y="144"/>
                </a:cubicBezTo>
                <a:cubicBezTo>
                  <a:pt x="672" y="168"/>
                  <a:pt x="1912" y="168"/>
                  <a:pt x="2208" y="144"/>
                </a:cubicBezTo>
                <a:cubicBezTo>
                  <a:pt x="2504" y="120"/>
                  <a:pt x="2128" y="24"/>
                  <a:pt x="2112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4343400" y="4648320"/>
            <a:ext cx="426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4" name=""/>
          <p:cNvGrpSpPr/>
          <p:nvPr/>
        </p:nvGrpSpPr>
        <p:grpSpPr>
          <a:xfrm>
            <a:off x="4421880" y="4572000"/>
            <a:ext cx="4176720" cy="366480"/>
            <a:chOff x="4421880" y="4572000"/>
            <a:chExt cx="4176720" cy="366480"/>
          </a:xfrm>
        </p:grpSpPr>
        <p:sp>
          <p:nvSpPr>
            <p:cNvPr id="265" name=""/>
            <p:cNvSpPr/>
            <p:nvPr/>
          </p:nvSpPr>
          <p:spPr>
            <a:xfrm>
              <a:off x="6461280" y="4572000"/>
              <a:ext cx="183960" cy="36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421880" y="4611600"/>
              <a:ext cx="824040" cy="215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50 bp of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G.O.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7774560" y="4611600"/>
              <a:ext cx="824040" cy="215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50 bp of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G.O.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5181480" y="4611600"/>
              <a:ext cx="2590920" cy="2156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                                 </a:t>
              </a: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TAG ( GFP or TAP)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9" name=""/>
          <p:cNvSpPr/>
          <p:nvPr/>
        </p:nvSpPr>
        <p:spPr>
          <a:xfrm>
            <a:off x="5867280" y="2971800"/>
            <a:ext cx="281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6019920" y="2895480"/>
            <a:ext cx="2606400" cy="215640"/>
          </a:xfrm>
          <a:prstGeom prst="rect">
            <a:avLst/>
          </a:prstGeom>
          <a:solidFill>
            <a:srgbClr val="00ff00"/>
          </a:solidFill>
          <a:ln w="93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F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1" name=""/>
          <p:cNvGrpSpPr/>
          <p:nvPr/>
        </p:nvGrpSpPr>
        <p:grpSpPr>
          <a:xfrm>
            <a:off x="1371600" y="762120"/>
            <a:ext cx="2133360" cy="337320"/>
            <a:chOff x="1371600" y="762120"/>
            <a:chExt cx="2133360" cy="337320"/>
          </a:xfrm>
        </p:grpSpPr>
        <p:sp>
          <p:nvSpPr>
            <p:cNvPr id="272" name=""/>
            <p:cNvSpPr/>
            <p:nvPr/>
          </p:nvSpPr>
          <p:spPr>
            <a:xfrm>
              <a:off x="1771560" y="762120"/>
              <a:ext cx="100008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2705040" y="762120"/>
              <a:ext cx="79992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371600" y="762120"/>
              <a:ext cx="468000" cy="337320"/>
            </a:xfrm>
            <a:prstGeom prst="rect">
              <a:avLst/>
            </a:prstGeom>
            <a:solidFill>
              <a:srgbClr val="cc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ompF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5" name=""/>
          <p:cNvGrpSpPr/>
          <p:nvPr/>
        </p:nvGrpSpPr>
        <p:grpSpPr>
          <a:xfrm>
            <a:off x="1981080" y="1752480"/>
            <a:ext cx="2133360" cy="337320"/>
            <a:chOff x="1981080" y="1752480"/>
            <a:chExt cx="2133360" cy="337320"/>
          </a:xfrm>
        </p:grpSpPr>
        <p:sp>
          <p:nvSpPr>
            <p:cNvPr id="276" name=""/>
            <p:cNvSpPr/>
            <p:nvPr/>
          </p:nvSpPr>
          <p:spPr>
            <a:xfrm>
              <a:off x="2381040" y="1752480"/>
              <a:ext cx="100008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3314520" y="1752480"/>
              <a:ext cx="79992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1981080" y="1752480"/>
              <a:ext cx="468000" cy="337320"/>
            </a:xfrm>
            <a:prstGeom prst="rect">
              <a:avLst/>
            </a:prstGeom>
            <a:solidFill>
              <a:srgbClr val="cc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ompF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9" name=""/>
          <p:cNvGrpSpPr/>
          <p:nvPr/>
        </p:nvGrpSpPr>
        <p:grpSpPr>
          <a:xfrm>
            <a:off x="2743200" y="3352680"/>
            <a:ext cx="2133360" cy="337320"/>
            <a:chOff x="2743200" y="3352680"/>
            <a:chExt cx="2133360" cy="337320"/>
          </a:xfrm>
        </p:grpSpPr>
        <p:sp>
          <p:nvSpPr>
            <p:cNvPr id="280" name=""/>
            <p:cNvSpPr/>
            <p:nvPr/>
          </p:nvSpPr>
          <p:spPr>
            <a:xfrm>
              <a:off x="3143160" y="3352680"/>
              <a:ext cx="1000080" cy="215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rps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4076640" y="3352680"/>
              <a:ext cx="799920" cy="215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      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Te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743200" y="3352680"/>
              <a:ext cx="468000" cy="337320"/>
            </a:xfrm>
            <a:prstGeom prst="rect">
              <a:avLst/>
            </a:prstGeom>
            <a:solidFill>
              <a:srgbClr val="cc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ompF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3" name=""/>
          <p:cNvSpPr/>
          <p:nvPr/>
        </p:nvSpPr>
        <p:spPr>
          <a:xfrm>
            <a:off x="460440" y="4378320"/>
            <a:ext cx="23648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Preparation of Competent cell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2</a:t>
            </a:r>
            <a:r>
              <a:rPr b="1" lang="en-US" sz="900" spc="-1" strike="noStrike" u="sng" baseline="30000">
                <a:solidFill>
                  <a:srgbClr val="3333cc"/>
                </a:solidFill>
                <a:uFillTx/>
                <a:latin typeface="Arial"/>
              </a:rPr>
              <a:t>nd</a:t>
            </a: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 recombineering with </a:t>
            </a:r>
            <a:r>
              <a:rPr b="1" lang="en-US" sz="900" spc="-1" strike="noStrike" u="sng">
                <a:solidFill>
                  <a:srgbClr val="009900"/>
                </a:solidFill>
                <a:uFillTx/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0000ff"/>
                </a:solidFill>
                <a:uFillTx/>
                <a:latin typeface="Arial"/>
              </a:rPr>
              <a:t>RT</a:t>
            </a:r>
            <a:r>
              <a:rPr b="1" lang="en-US" sz="900" spc="-1" strike="noStrike" u="sng">
                <a:solidFill>
                  <a:srgbClr val="009900"/>
                </a:solidFill>
                <a:uFillTx/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negative 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hypotonic media (Str+Chl+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283840" y="1447920"/>
            <a:ext cx="211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High fidelity PCR and gel–recovery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8001000" y="5867280"/>
            <a:ext cx="609480" cy="215640"/>
          </a:xfrm>
          <a:prstGeom prst="rect">
            <a:avLst/>
          </a:prstGeom>
          <a:solidFill>
            <a:srgbClr val="ff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mp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8001000" y="6553080"/>
            <a:ext cx="609480" cy="215640"/>
          </a:xfrm>
          <a:prstGeom prst="rect">
            <a:avLst/>
          </a:prstGeom>
          <a:solidFill>
            <a:srgbClr val="ff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mp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762120" y="5334120"/>
            <a:ext cx="76176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4114800" y="251460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457200" y="358128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609480" y="664380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"/>
          <p:cNvSpPr/>
          <p:nvPr/>
        </p:nvSpPr>
        <p:spPr>
          <a:xfrm>
            <a:off x="1447920" y="457200"/>
            <a:ext cx="380880" cy="228600"/>
          </a:xfrm>
          <a:prstGeom prst="line">
            <a:avLst/>
          </a:prstGeom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1828800" y="685800"/>
            <a:ext cx="304920" cy="0"/>
          </a:xfrm>
          <a:prstGeom prst="line">
            <a:avLst/>
          </a:prstGeom>
          <a:ln w="9360">
            <a:solidFill>
              <a:srgbClr val="00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 flipH="1">
            <a:off x="3733920" y="1066680"/>
            <a:ext cx="380880" cy="0"/>
          </a:xfrm>
          <a:prstGeom prst="line">
            <a:avLst/>
          </a:prstGeom>
          <a:ln w="9360">
            <a:solidFill>
              <a:srgbClr val="00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4114800" y="1066680"/>
            <a:ext cx="304920" cy="228600"/>
          </a:xfrm>
          <a:prstGeom prst="line">
            <a:avLst/>
          </a:prstGeom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4037040" y="1143000"/>
            <a:ext cx="161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0 bp homology arm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f</a:t>
            </a:r>
            <a:r>
              <a:rPr b="1" lang="en-US" sz="8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ff3300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-1800" y="152280"/>
            <a:ext cx="161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0 bp homology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rm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f</a:t>
            </a:r>
            <a:r>
              <a:rPr b="0" lang="en-US" sz="8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ff3300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914400" y="1905120"/>
            <a:ext cx="419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4193280" y="1752480"/>
            <a:ext cx="8240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50 bp of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143000" y="1752480"/>
            <a:ext cx="91440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50 bp of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5788080" y="492120"/>
            <a:ext cx="2921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ulture of Fosmid clone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ene of Interest (G.O.I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7086600" y="6858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5790240" y="762120"/>
            <a:ext cx="206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Extraction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Fosmid  DNA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5788080" y="1143000"/>
            <a:ext cx="296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ransformation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</a:t>
            </a:r>
            <a:r>
              <a:rPr b="1" lang="en-US" sz="9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smid DNAs into SW106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7086600" y="10666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7086600" y="1523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5791320" y="1676520"/>
            <a:ext cx="311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reparation of  SW106 Competent  cells of </a:t>
            </a:r>
            <a:r>
              <a:rPr b="1" lang="en-US" sz="900" spc="-1" strike="noStrike">
                <a:solidFill>
                  <a:srgbClr val="ff3300"/>
                </a:solidFill>
                <a:latin typeface="Arial"/>
              </a:rPr>
              <a:t>G.O.I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smid DNAs with  induction in water bat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743200" y="13716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1905120" y="1981080"/>
            <a:ext cx="2590560" cy="30492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1143000" y="1981080"/>
            <a:ext cx="3581280" cy="30492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4267080" y="1981080"/>
            <a:ext cx="762120" cy="30492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 flipH="1">
            <a:off x="4648320" y="1981080"/>
            <a:ext cx="380880" cy="304920"/>
          </a:xfrm>
          <a:prstGeom prst="line">
            <a:avLst/>
          </a:prstGeom>
          <a:ln w="936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886200" y="2666880"/>
            <a:ext cx="76320" cy="457200"/>
          </a:xfrm>
          <a:prstGeom prst="downArrow">
            <a:avLst>
              <a:gd name="adj1" fmla="val 50000"/>
              <a:gd name="adj2" fmla="val 149764"/>
            </a:avLst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304200" y="4343400"/>
            <a:ext cx="364932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2</a:t>
            </a:r>
            <a:r>
              <a:rPr b="1" lang="en-US" sz="900" spc="-1" strike="noStrike" u="sng" baseline="30000">
                <a:solidFill>
                  <a:srgbClr val="3333cc"/>
                </a:solidFill>
                <a:uFillTx/>
                <a:latin typeface="Arial"/>
              </a:rPr>
              <a:t>nd</a:t>
            </a: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 recombineering with </a:t>
            </a:r>
            <a:r>
              <a:rPr b="1" lang="en-US" sz="900" spc="-1" strike="noStrike" u="sng">
                <a:solidFill>
                  <a:srgbClr val="009900"/>
                </a:solidFill>
                <a:uFillTx/>
                <a:latin typeface="Arial"/>
              </a:rPr>
              <a:t>2-Deoxy-galactose</a:t>
            </a: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 negative selection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(Chl+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3886200" y="4343400"/>
            <a:ext cx="76320" cy="609480"/>
          </a:xfrm>
          <a:prstGeom prst="downArrow">
            <a:avLst>
              <a:gd name="adj1" fmla="val 50000"/>
              <a:gd name="adj2" fmla="val 199646"/>
            </a:avLst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227160" y="2590920"/>
            <a:ext cx="350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1</a:t>
            </a:r>
            <a:r>
              <a:rPr b="1" lang="en-US" sz="900" spc="-1" strike="noStrike" u="sng" baseline="30000">
                <a:solidFill>
                  <a:srgbClr val="ff33cc"/>
                </a:solidFill>
                <a:uFillTx/>
                <a:latin typeface="Arial"/>
              </a:rPr>
              <a:t>st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  recombineering with</a:t>
            </a:r>
            <a:r>
              <a:rPr b="1" lang="en-US" sz="900" spc="-1" strike="noStrike" u="sng">
                <a:solidFill>
                  <a:srgbClr val="ff0000"/>
                </a:solidFill>
                <a:uFillTx/>
                <a:latin typeface="Arial"/>
              </a:rPr>
              <a:t> </a:t>
            </a:r>
            <a:r>
              <a:rPr b="1" lang="en-US" sz="900" spc="-1" strike="noStrike" u="sng">
                <a:solidFill>
                  <a:srgbClr val="009900"/>
                </a:solidFill>
                <a:uFillTx/>
                <a:latin typeface="Arial"/>
              </a:rPr>
              <a:t>galactose  </a:t>
            </a:r>
            <a:r>
              <a:rPr b="1" lang="en-US" sz="900" spc="-1" strike="noStrike" u="sng">
                <a:solidFill>
                  <a:srgbClr val="ff33cc"/>
                </a:solidFill>
                <a:uFillTx/>
                <a:latin typeface="Arial"/>
              </a:rPr>
              <a:t>positive selection (Chl+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8155440" y="3646440"/>
            <a:ext cx="43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o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 flipH="1">
            <a:off x="3200040" y="3124080"/>
            <a:ext cx="304812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 flipH="1">
            <a:off x="2742840" y="3124080"/>
            <a:ext cx="3809880" cy="22860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flipV="1">
            <a:off x="4572000" y="3123720"/>
            <a:ext cx="403848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flipV="1">
            <a:off x="4876920" y="3123720"/>
            <a:ext cx="3733560" cy="22860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H="1" flipV="1">
            <a:off x="2437920" y="3581280"/>
            <a:ext cx="3124440" cy="99072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 flipH="1" flipV="1">
            <a:off x="3047760" y="3581280"/>
            <a:ext cx="1447560" cy="99072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4572000" y="3581280"/>
            <a:ext cx="3962520" cy="99072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5181480" y="3581280"/>
            <a:ext cx="2362320" cy="990720"/>
          </a:xfrm>
          <a:prstGeom prst="line">
            <a:avLst/>
          </a:prstGeom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581280" y="2362320"/>
            <a:ext cx="5410440" cy="266760"/>
          </a:xfrm>
          <a:custGeom>
            <a:avLst/>
            <a:gdLst/>
            <a:ahLst/>
            <a:rect l="l" t="t" r="r" b="b"/>
            <a:pathLst>
              <a:path w="3664" h="168">
                <a:moveTo>
                  <a:pt x="336" y="0"/>
                </a:moveTo>
                <a:cubicBezTo>
                  <a:pt x="168" y="60"/>
                  <a:pt x="0" y="120"/>
                  <a:pt x="480" y="144"/>
                </a:cubicBezTo>
                <a:cubicBezTo>
                  <a:pt x="960" y="168"/>
                  <a:pt x="2768" y="168"/>
                  <a:pt x="3216" y="144"/>
                </a:cubicBezTo>
                <a:cubicBezTo>
                  <a:pt x="3664" y="120"/>
                  <a:pt x="3416" y="60"/>
                  <a:pt x="3168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886200" y="5715000"/>
            <a:ext cx="76320" cy="609480"/>
          </a:xfrm>
          <a:prstGeom prst="downArrow">
            <a:avLst>
              <a:gd name="adj1" fmla="val 50000"/>
              <a:gd name="adj2" fmla="val 199646"/>
            </a:avLst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4572000" y="5715000"/>
            <a:ext cx="3657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6934320" y="5638680"/>
            <a:ext cx="1218960" cy="215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MO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5334120" y="5638680"/>
            <a:ext cx="1523880" cy="215640"/>
          </a:xfrm>
          <a:prstGeom prst="rect">
            <a:avLst/>
          </a:prstGeom>
          <a:solidFill>
            <a:srgbClr val="99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UNC-1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4572000" y="563868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4165560" y="5715000"/>
            <a:ext cx="4775400" cy="266760"/>
          </a:xfrm>
          <a:custGeom>
            <a:avLst/>
            <a:gdLst/>
            <a:ahLst/>
            <a:rect l="l" t="t" r="r" b="b"/>
            <a:pathLst>
              <a:path w="3008" h="168">
                <a:moveTo>
                  <a:pt x="256" y="0"/>
                </a:moveTo>
                <a:cubicBezTo>
                  <a:pt x="128" y="60"/>
                  <a:pt x="0" y="120"/>
                  <a:pt x="400" y="144"/>
                </a:cubicBezTo>
                <a:cubicBezTo>
                  <a:pt x="800" y="168"/>
                  <a:pt x="2304" y="168"/>
                  <a:pt x="2656" y="144"/>
                </a:cubicBezTo>
                <a:cubicBezTo>
                  <a:pt x="3008" y="120"/>
                  <a:pt x="2536" y="24"/>
                  <a:pt x="2512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6400800" y="5867280"/>
            <a:ext cx="9907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oxP-UNC-11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300600" y="5867280"/>
            <a:ext cx="358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99cc00"/>
                </a:solidFill>
                <a:uFillTx/>
                <a:latin typeface="Arial"/>
              </a:rPr>
              <a:t>pLoxP / Cre recombineering with 0.1% arabinose (AMP+Chl+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4595760" y="6400800"/>
            <a:ext cx="20336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685800" y="6400800"/>
            <a:ext cx="190512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G.O.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6705720" y="6400800"/>
            <a:ext cx="1218960" cy="215640"/>
          </a:xfrm>
          <a:prstGeom prst="rect">
            <a:avLst/>
          </a:prstGeom>
          <a:solidFill>
            <a:srgbClr val="99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UNC-1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-304920" y="6477120"/>
            <a:ext cx="9372600" cy="266760"/>
          </a:xfrm>
          <a:custGeom>
            <a:avLst/>
            <a:gdLst/>
            <a:ahLst/>
            <a:rect l="l" t="t" r="r" b="b"/>
            <a:pathLst>
              <a:path w="6168" h="168">
                <a:moveTo>
                  <a:pt x="648" y="0"/>
                </a:moveTo>
                <a:cubicBezTo>
                  <a:pt x="324" y="60"/>
                  <a:pt x="0" y="120"/>
                  <a:pt x="792" y="144"/>
                </a:cubicBezTo>
                <a:cubicBezTo>
                  <a:pt x="1584" y="168"/>
                  <a:pt x="4632" y="160"/>
                  <a:pt x="5400" y="144"/>
                </a:cubicBezTo>
                <a:cubicBezTo>
                  <a:pt x="6168" y="128"/>
                  <a:pt x="5400" y="64"/>
                  <a:pt x="5400" y="48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6629400" y="65530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7086600" y="20574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5792400" y="5334120"/>
            <a:ext cx="3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99cc00"/>
                </a:solidFill>
                <a:latin typeface="Arial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205080" y="76320"/>
            <a:ext cx="3143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gal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recombineering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990720" y="3962520"/>
            <a:ext cx="281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Verifying on MacConkey Agar individuall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 u="sng">
                <a:solidFill>
                  <a:srgbClr val="3333cc"/>
                </a:solidFill>
                <a:uFillTx/>
                <a:latin typeface="Arial"/>
              </a:rPr>
              <a:t>Preparation of Competent cells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8686800" y="609480"/>
            <a:ext cx="76320" cy="1371600"/>
          </a:xfrm>
          <a:custGeom>
            <a:avLst/>
            <a:gdLst>
              <a:gd name="textAreaLeft" fmla="*/ 0 w 76320"/>
              <a:gd name="textAreaRight" fmla="*/ 53640 w 76320"/>
              <a:gd name="textAreaTop" fmla="*/ 56880 h 1371600"/>
              <a:gd name="textAreaBottom" fmla="*/ 1314720 h 1371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8748720" y="110016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8686800" y="2057400"/>
            <a:ext cx="76320" cy="990720"/>
          </a:xfrm>
          <a:custGeom>
            <a:avLst/>
            <a:gdLst>
              <a:gd name="textAreaLeft" fmla="*/ 0 w 76320"/>
              <a:gd name="textAreaRight" fmla="*/ 53640 w 76320"/>
              <a:gd name="textAreaTop" fmla="*/ 41040 h 990720"/>
              <a:gd name="textAreaBottom" fmla="*/ 949680 h 990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8740440" y="236232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.5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2514600" y="3809880"/>
            <a:ext cx="76320" cy="228600"/>
          </a:xfrm>
          <a:prstGeom prst="downArrow">
            <a:avLst>
              <a:gd name="adj1" fmla="val 50000"/>
              <a:gd name="adj2" fmla="val 74882"/>
            </a:avLst>
          </a:prstGeom>
          <a:solidFill>
            <a:srgbClr val="bbe0e3"/>
          </a:solidFill>
          <a:ln w="9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3581280" y="4267080"/>
            <a:ext cx="228600" cy="76320"/>
          </a:xfrm>
          <a:prstGeom prst="line">
            <a:avLst/>
          </a:prstGeom>
          <a:ln w="9360">
            <a:solidFill>
              <a:srgbClr val="3333cc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8686800" y="3124080"/>
            <a:ext cx="76320" cy="2286000"/>
          </a:xfrm>
          <a:custGeom>
            <a:avLst/>
            <a:gdLst>
              <a:gd name="textAreaLeft" fmla="*/ 0 w 76320"/>
              <a:gd name="textAreaRight" fmla="*/ 53640 w 76320"/>
              <a:gd name="textAreaTop" fmla="*/ 95040 h 2286000"/>
              <a:gd name="textAreaBottom" fmla="*/ 2190960 h 2286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8740800" y="411480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8740800" y="563868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8686800" y="5486400"/>
            <a:ext cx="76320" cy="1295280"/>
          </a:xfrm>
          <a:custGeom>
            <a:avLst/>
            <a:gdLst>
              <a:gd name="textAreaLeft" fmla="*/ 0 w 76320"/>
              <a:gd name="textAreaRight" fmla="*/ 53640 w 76320"/>
              <a:gd name="textAreaTop" fmla="*/ 53640 h 1295280"/>
              <a:gd name="textAreaBottom" fmla="*/ 1241640 h 1295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4116240" y="762120"/>
            <a:ext cx="560160" cy="215640"/>
          </a:xfrm>
          <a:prstGeom prst="rect">
            <a:avLst/>
          </a:prstGeom>
          <a:solidFill>
            <a:srgbClr val="cc00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pMOD4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4" name=""/>
          <p:cNvGrpSpPr/>
          <p:nvPr/>
        </p:nvGrpSpPr>
        <p:grpSpPr>
          <a:xfrm>
            <a:off x="1905120" y="762120"/>
            <a:ext cx="2209680" cy="215640"/>
            <a:chOff x="1905120" y="762120"/>
            <a:chExt cx="2209680" cy="215640"/>
          </a:xfrm>
        </p:grpSpPr>
        <p:sp>
          <p:nvSpPr>
            <p:cNvPr id="355" name=""/>
            <p:cNvSpPr/>
            <p:nvPr/>
          </p:nvSpPr>
          <p:spPr>
            <a:xfrm>
              <a:off x="1905120" y="762120"/>
              <a:ext cx="380880" cy="2142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2286000" y="762120"/>
              <a:ext cx="1371600" cy="215640"/>
            </a:xfrm>
            <a:prstGeom prst="rect">
              <a:avLst/>
            </a:prstGeom>
            <a:solidFill>
              <a:srgbClr val="00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Gal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3657600" y="762120"/>
              <a:ext cx="457200" cy="2142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8" name=""/>
          <p:cNvGrpSpPr/>
          <p:nvPr/>
        </p:nvGrpSpPr>
        <p:grpSpPr>
          <a:xfrm>
            <a:off x="1981080" y="1752480"/>
            <a:ext cx="2209680" cy="215640"/>
            <a:chOff x="1981080" y="1752480"/>
            <a:chExt cx="2209680" cy="215640"/>
          </a:xfrm>
        </p:grpSpPr>
        <p:sp>
          <p:nvSpPr>
            <p:cNvPr id="359" name=""/>
            <p:cNvSpPr/>
            <p:nvPr/>
          </p:nvSpPr>
          <p:spPr>
            <a:xfrm>
              <a:off x="1981080" y="1752480"/>
              <a:ext cx="380880" cy="2142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2361960" y="1752480"/>
              <a:ext cx="1371600" cy="215640"/>
            </a:xfrm>
            <a:prstGeom prst="rect">
              <a:avLst/>
            </a:prstGeom>
            <a:solidFill>
              <a:srgbClr val="00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Gal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3733560" y="1752480"/>
              <a:ext cx="457200" cy="2142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2" name=""/>
          <p:cNvGrpSpPr/>
          <p:nvPr/>
        </p:nvGrpSpPr>
        <p:grpSpPr>
          <a:xfrm>
            <a:off x="2743200" y="3352680"/>
            <a:ext cx="2209680" cy="215640"/>
            <a:chOff x="2743200" y="3352680"/>
            <a:chExt cx="2209680" cy="215640"/>
          </a:xfrm>
        </p:grpSpPr>
        <p:sp>
          <p:nvSpPr>
            <p:cNvPr id="363" name=""/>
            <p:cNvSpPr/>
            <p:nvPr/>
          </p:nvSpPr>
          <p:spPr>
            <a:xfrm>
              <a:off x="2743200" y="3352680"/>
              <a:ext cx="380880" cy="2142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3124080" y="3352680"/>
              <a:ext cx="1371600" cy="215640"/>
            </a:xfrm>
            <a:prstGeom prst="rect">
              <a:avLst/>
            </a:prstGeom>
            <a:solidFill>
              <a:srgbClr val="00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Gal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4495680" y="3352680"/>
              <a:ext cx="457200" cy="2142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6" name=""/>
          <p:cNvSpPr/>
          <p:nvPr/>
        </p:nvSpPr>
        <p:spPr>
          <a:xfrm>
            <a:off x="2666880" y="5105520"/>
            <a:ext cx="228600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TAG (GFP or TA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1066680" y="3352680"/>
            <a:ext cx="167652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4952880" y="3352680"/>
            <a:ext cx="19814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  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4114800" y="2286000"/>
            <a:ext cx="411480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                                                                 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990720" y="5105520"/>
            <a:ext cx="175248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      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4952880" y="5105520"/>
            <a:ext cx="1981440" cy="21564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                        </a:t>
            </a: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G.O.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2438280" y="6400800"/>
            <a:ext cx="221616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TAG ( GFP or TA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4419720" y="4648320"/>
            <a:ext cx="426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6019920" y="2971800"/>
            <a:ext cx="2666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6095880" y="2895480"/>
            <a:ext cx="2590920" cy="2156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           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TAG (GFP or TAP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6" name=""/>
          <p:cNvGrpSpPr/>
          <p:nvPr/>
        </p:nvGrpSpPr>
        <p:grpSpPr>
          <a:xfrm>
            <a:off x="4497840" y="4572000"/>
            <a:ext cx="4100760" cy="366480"/>
            <a:chOff x="4497840" y="4572000"/>
            <a:chExt cx="4100760" cy="366480"/>
          </a:xfrm>
        </p:grpSpPr>
        <p:sp>
          <p:nvSpPr>
            <p:cNvPr id="377" name=""/>
            <p:cNvSpPr/>
            <p:nvPr/>
          </p:nvSpPr>
          <p:spPr>
            <a:xfrm>
              <a:off x="6461280" y="4572000"/>
              <a:ext cx="183960" cy="36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4497840" y="4611600"/>
              <a:ext cx="824040" cy="215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50 bp of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G.O.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7774560" y="4611600"/>
              <a:ext cx="824040" cy="215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50 bp of </a:t>
              </a:r>
              <a:r>
                <a:rPr b="1" lang="en-US" sz="800" spc="-1" strike="noStrike">
                  <a:solidFill>
                    <a:srgbClr val="ffffff"/>
                  </a:solidFill>
                  <a:latin typeface="Arial"/>
                </a:rPr>
                <a:t>G.O.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5257800" y="4611600"/>
              <a:ext cx="2590920" cy="2156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           </a:t>
              </a: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TAG (GFP or TAP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1" name=""/>
          <p:cNvSpPr/>
          <p:nvPr/>
        </p:nvSpPr>
        <p:spPr>
          <a:xfrm>
            <a:off x="291960" y="3429000"/>
            <a:ext cx="7734600" cy="266760"/>
          </a:xfrm>
          <a:custGeom>
            <a:avLst/>
            <a:gdLst/>
            <a:ahLst/>
            <a:rect l="l" t="t" r="r" b="b"/>
            <a:pathLst>
              <a:path w="4872" h="168">
                <a:moveTo>
                  <a:pt x="488" y="0"/>
                </a:moveTo>
                <a:cubicBezTo>
                  <a:pt x="244" y="60"/>
                  <a:pt x="0" y="120"/>
                  <a:pt x="632" y="144"/>
                </a:cubicBezTo>
                <a:cubicBezTo>
                  <a:pt x="1264" y="168"/>
                  <a:pt x="3688" y="168"/>
                  <a:pt x="4280" y="144"/>
                </a:cubicBezTo>
                <a:cubicBezTo>
                  <a:pt x="4872" y="120"/>
                  <a:pt x="4200" y="24"/>
                  <a:pt x="4184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216000" y="5181480"/>
            <a:ext cx="7746840" cy="355680"/>
          </a:xfrm>
          <a:custGeom>
            <a:avLst/>
            <a:gdLst/>
            <a:ahLst/>
            <a:rect l="l" t="t" r="r" b="b"/>
            <a:pathLst>
              <a:path w="4880" h="224">
                <a:moveTo>
                  <a:pt x="488" y="0"/>
                </a:moveTo>
                <a:cubicBezTo>
                  <a:pt x="244" y="80"/>
                  <a:pt x="0" y="160"/>
                  <a:pt x="632" y="192"/>
                </a:cubicBezTo>
                <a:cubicBezTo>
                  <a:pt x="1264" y="224"/>
                  <a:pt x="3680" y="224"/>
                  <a:pt x="4280" y="192"/>
                </a:cubicBezTo>
                <a:cubicBezTo>
                  <a:pt x="4880" y="160"/>
                  <a:pt x="4556" y="80"/>
                  <a:pt x="4232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1447920" y="914400"/>
            <a:ext cx="3873240" cy="177840"/>
          </a:xfrm>
          <a:custGeom>
            <a:avLst/>
            <a:gdLst/>
            <a:ahLst/>
            <a:rect l="l" t="t" r="r" b="b"/>
            <a:pathLst>
              <a:path w="2440" h="112">
                <a:moveTo>
                  <a:pt x="224" y="0"/>
                </a:moveTo>
                <a:cubicBezTo>
                  <a:pt x="112" y="40"/>
                  <a:pt x="0" y="80"/>
                  <a:pt x="320" y="96"/>
                </a:cubicBezTo>
                <a:cubicBezTo>
                  <a:pt x="640" y="112"/>
                  <a:pt x="1848" y="112"/>
                  <a:pt x="2144" y="96"/>
                </a:cubicBezTo>
                <a:cubicBezTo>
                  <a:pt x="2440" y="80"/>
                  <a:pt x="2268" y="40"/>
                  <a:pt x="2096" y="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152280" y="838080"/>
            <a:ext cx="12956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MOD4GalK-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2893320" y="1447920"/>
            <a:ext cx="211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High fidelity PCR and gel–recovery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990720" y="5410080"/>
            <a:ext cx="76176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8001000" y="6477120"/>
            <a:ext cx="609480" cy="215640"/>
          </a:xfrm>
          <a:prstGeom prst="rect">
            <a:avLst/>
          </a:prstGeom>
          <a:solidFill>
            <a:srgbClr val="ff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mp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8077320" y="5867280"/>
            <a:ext cx="609480" cy="215640"/>
          </a:xfrm>
          <a:prstGeom prst="rect">
            <a:avLst/>
          </a:prstGeom>
          <a:solidFill>
            <a:srgbClr val="ff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mp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1066680" y="358128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4114800" y="251460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685800" y="6643800"/>
            <a:ext cx="762120" cy="215640"/>
          </a:xfrm>
          <a:prstGeom prst="rect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x 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3T03:39:12Z</dcterms:created>
  <dc:creator>FisherA</dc:creator>
  <dc:description/>
  <dc:language>en-US</dc:language>
  <cp:lastModifiedBy>FisherA</cp:lastModifiedBy>
  <dcterms:modified xsi:type="dcterms:W3CDTF">2008-10-13T21:11:29Z</dcterms:modified>
  <cp:revision>7</cp:revision>
  <dc:subject/>
  <dc:title>Slide 1</dc:title>
</cp:coreProperties>
</file>